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32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3EAAF2-5CBE-E449-2479-79858F2B3B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CF134EA-B83C-C890-DF96-47EF1AD313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D1DFDCC-F4D4-C947-FCBA-51F756B25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164FA-EC22-4F69-8283-D0A3CA1BC15E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0819061-EFB6-3764-7FE1-EF0F22B57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6230B42-01D0-6530-87CC-2A91B78B4B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8EA87-430D-4A7A-83D9-88D2C5589F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1052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4E49F19-1F58-5A3E-60DF-CCED87FED3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FFF57A7-7D83-2627-D512-7AB75A43DE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66411C0-1E93-252F-9580-2F2204DD0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164FA-EC22-4F69-8283-D0A3CA1BC15E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A066408-035C-C4A8-AEBF-02EC161BB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BFF5BA-D11A-6896-56A7-5FFEBB01A8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8EA87-430D-4A7A-83D9-88D2C5589F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676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373AEBF-6423-5594-B626-955242878A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57E40D4-2C04-D737-7E47-0AEA32E464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4A4864E-1692-E0A8-A59A-3E819DD9A4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164FA-EC22-4F69-8283-D0A3CA1BC15E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E5F6DFE-CD30-0D8B-E2A5-8A8AE0A0CD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D8C7F6-2A18-C1EB-E7B1-5F14FAC38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8EA87-430D-4A7A-83D9-88D2C5589F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2508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1DE2F6-B099-3531-4697-56C3DA32A7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7D44B24-6A84-DF92-6426-993C7EF914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196A17-8127-1341-1DFA-493A26447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164FA-EC22-4F69-8283-D0A3CA1BC15E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BF4D804-74E5-518B-1BCD-50ACDED1C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A3B8D63-E5FC-EAC0-3018-26232B9EB2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8EA87-430D-4A7A-83D9-88D2C5589F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8481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AFA60C-9F80-9040-D4CB-0D7A40F923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9D4CAC6-54D2-CC73-5DBE-0AAE994F23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325745F-5E74-9BF9-FF47-DB3CC968D1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164FA-EC22-4F69-8283-D0A3CA1BC15E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C1F3C29-38C3-5A46-880D-F1EA7258B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6BBEA27-7995-4FCC-AE78-BE4F63A15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8EA87-430D-4A7A-83D9-88D2C5589F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8522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D5B4C3-3D91-94AC-B012-92D4AA6ECC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35B429C-BF41-D90B-C142-C394B9F52D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B9746C0-93B1-88FE-35FB-72442682CC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BB6B984-C8F7-6159-9DEA-BD4833ADF8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164FA-EC22-4F69-8283-D0A3CA1BC15E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A85A50C-98D3-22D9-4179-29BBC0F64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91E4110-9BE2-65B7-30B9-DAC96C905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8EA87-430D-4A7A-83D9-88D2C5589F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1405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695FF1-E13C-6B50-A662-120EE054C6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D6C376E-58B2-8D2F-1966-B1C8AFF057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F4E8161-700E-1B88-871D-6C8DF36EA0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039F276-041C-EDE5-6C46-8B769252CA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5BB4E7C-35E1-30EF-476E-2B9DF10549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BE2E028-37D9-5206-F073-25D1057889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164FA-EC22-4F69-8283-D0A3CA1BC15E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AF596EE-7465-D755-6C1B-8E8E407CF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288FDBF-522D-55FF-2074-7E4D630A9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8EA87-430D-4A7A-83D9-88D2C5589F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1618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C526B3-5B4D-244D-4E79-B281EE3485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ADBC609-1C65-348F-6AE7-3A1332759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164FA-EC22-4F69-8283-D0A3CA1BC15E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D4B55B6-7CB2-EC69-BEF6-13F6C1046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9EB8128-988F-586F-13AD-41930469DC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8EA87-430D-4A7A-83D9-88D2C5589F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9292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1A0B344-578C-1A7F-34F9-D64E255F8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164FA-EC22-4F69-8283-D0A3CA1BC15E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3B0A261-8892-CCBF-9BA3-86B5BF172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A572719-84A8-3819-E3A6-449435DB3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8EA87-430D-4A7A-83D9-88D2C5589F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387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9B829D-B996-B18C-EF16-CC0BD0E33D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653574D-4544-3C72-518B-912BD00E12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426BC0A-75B8-83CB-F6EA-3692C5585B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859AFDD-815C-3855-D27C-A83A2B4B1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164FA-EC22-4F69-8283-D0A3CA1BC15E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A72EFF3-2B1C-0A7C-EB61-3F1AF3A02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9BBDE8C-A431-E2CB-46D3-BEAAAEA44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8EA87-430D-4A7A-83D9-88D2C5589F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9964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83EEA2-78E6-F1DF-C965-DA81F61805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2861DE2-37F1-8857-89D7-115684A88E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A5F3DB1-B81D-3699-C10D-682F94A47C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08C3E57-B76C-21AE-FC08-9F15F1DB7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164FA-EC22-4F69-8283-D0A3CA1BC15E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6E45098-34F0-F048-78E0-5210BD3F0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3819A1F-788C-569D-DA42-6A452C0B2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08EA87-430D-4A7A-83D9-88D2C5589F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1603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AB3478C-9A3A-7561-22A3-7A763762F1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DBBDA8-9C02-0169-5226-055A351563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33A68A-C5CB-1FA4-CAE0-8B86D0BC6D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8164FA-EC22-4F69-8283-D0A3CA1BC15E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806F1CF-5E51-8CEC-5912-3C3A1E4C63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D19B8D6-ED91-2831-3605-88C2E53F16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08EA87-430D-4A7A-83D9-88D2C5589F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3392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BF20B485-B096-F850-CECC-FAFEA8A42C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623419"/>
              </p:ext>
            </p:extLst>
          </p:nvPr>
        </p:nvGraphicFramePr>
        <p:xfrm>
          <a:off x="0" y="0"/>
          <a:ext cx="12192000" cy="687232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834640">
                  <a:extLst>
                    <a:ext uri="{9D8B030D-6E8A-4147-A177-3AD203B41FA5}">
                      <a16:colId xmlns:a16="http://schemas.microsoft.com/office/drawing/2014/main" val="1393240099"/>
                    </a:ext>
                  </a:extLst>
                </a:gridCol>
                <a:gridCol w="8446770">
                  <a:extLst>
                    <a:ext uri="{9D8B030D-6E8A-4147-A177-3AD203B41FA5}">
                      <a16:colId xmlns:a16="http://schemas.microsoft.com/office/drawing/2014/main" val="569999830"/>
                    </a:ext>
                  </a:extLst>
                </a:gridCol>
                <a:gridCol w="910590">
                  <a:extLst>
                    <a:ext uri="{9D8B030D-6E8A-4147-A177-3AD203B41FA5}">
                      <a16:colId xmlns:a16="http://schemas.microsoft.com/office/drawing/2014/main" val="655457871"/>
                    </a:ext>
                  </a:extLst>
                </a:gridCol>
              </a:tblGrid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cor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9726303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 Underlying diseases *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209315604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</a:t>
                      </a:r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Abruptio placenta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iffening of the uterus, death of the fetu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077934164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iffening of the uterus, survival of the fetu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123628133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firmatory diagnosis of placental abruption by ultrasonographic findings and CTG finding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057146132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. Amniotic fluid embolis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ute </a:t>
                      </a:r>
                      <a:r>
                        <a:rPr lang="en-US" sz="11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</a:t>
                      </a:r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ulmon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96526236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ificial ventila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3807320592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sisted respira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2383508072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xygen flux alo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2986682450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. DIC-type postpartum hemorrhag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 case the blood from the uterus has low coagulabilit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7113398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orrhage of ≤ 2,000 mL (within 24 h after the start of hemorrhage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3575818487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orrhage of ≤ 1,000 mL, but not exceeding 2,000 mL (within 24 h after the start of hemorrhage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337298086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. Eclampsi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lamptic attack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100347298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. Other underlying disea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748097159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434070277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 Clinical symptom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653254556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. Acute renal failur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uria (≤ 5 mL/h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375373779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iguria (5-20 mL/h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969246585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. Acute respiratory failur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ificial ventilation or occasional assisted respira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624632908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amniotic fluid embolism excluded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xygen flux alo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307922776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. Organ failur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rt (rales or foamy sputum, etc.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350498899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ver (visible jaundice, etc.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3862894654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in (clouding of consciousness, convulsion, etc.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2883497233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gestive tract (necrotic enteritis, etc.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071962561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severe organ failur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3400652031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. Hemorrhage diathesi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roscopic hematuria and melena, purpura, hemorrhage from the mucous membrane, gingival bleeding, bleeding at the site of injection, etc.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994390268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. Shock symptom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lse rate ≥ 100 /mi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3591950695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 pressure ≤ 90 mmHg (systolic) or blood pressure reduction of ≥ 40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891040288"/>
                  </a:ext>
                </a:extLst>
              </a:tr>
              <a:tr h="19446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d swe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3467210985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llo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919493397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039754921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 Laboratory finding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a-DK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um FDP ≥ 10 µg/mL</a:t>
                      </a:r>
                      <a:endParaRPr lang="da-DK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3013062576"/>
                  </a:ext>
                </a:extLst>
              </a:tr>
              <a:tr h="19354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telet counts ≤ </a:t>
                      </a:r>
                      <a:r>
                        <a:rPr lang="en-US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× </a:t>
                      </a:r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100" b="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/µ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4269567164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brinogen ≤ 150 mg/d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3377113663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 ≥ 15 (sec) (≤ 50%) or </a:t>
                      </a:r>
                      <a:r>
                        <a:rPr lang="en-US" sz="11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paplastin</a:t>
                      </a:r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est ≤ 50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2223055634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ythrocyte sedimentation rate ≤ 4 mm/15 min or ≤ 15 mm/h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3260134250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eeding time ≥ 5 mi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1504299"/>
                  </a:ext>
                </a:extLst>
              </a:tr>
              <a:tr h="18012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coagulation and fibrinolysis factors; </a:t>
                      </a:r>
                      <a:r>
                        <a:rPr lang="en-US" altLang="ja-JP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 ≤ 18 mg/dL or ≤ 60%, </a:t>
                      </a:r>
                      <a:r>
                        <a:rPr lang="en-US" altLang="ja-JP" sz="11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kallikrein</a:t>
                      </a:r>
                      <a:r>
                        <a:rPr lang="en-US" altLang="ja-JP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l-GR" altLang="ja-JP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2-</a:t>
                      </a:r>
                      <a:r>
                        <a:rPr lang="en-US" altLang="ja-JP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, plasminogen, other coagulation factors ≤ 50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343" marR="4343" marT="4343" marB="0" anchor="ctr"/>
                </a:tc>
                <a:extLst>
                  <a:ext uri="{0D108BD9-81ED-4DB2-BD59-A6C34878D82A}">
                    <a16:rowId xmlns:a16="http://schemas.microsoft.com/office/drawing/2014/main" val="40589645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3064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393</Words>
  <Application>Microsoft Office PowerPoint</Application>
  <PresentationFormat>ワイド画面</PresentationFormat>
  <Paragraphs>8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shida Yoshiaki</dc:creator>
  <cp:lastModifiedBy>Ishida Yoshiaki</cp:lastModifiedBy>
  <cp:revision>7</cp:revision>
  <dcterms:created xsi:type="dcterms:W3CDTF">2022-07-23T13:11:36Z</dcterms:created>
  <dcterms:modified xsi:type="dcterms:W3CDTF">2022-07-23T14:40:10Z</dcterms:modified>
</cp:coreProperties>
</file>